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33"/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79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087011\Desktop\Density\H3911&#33258;&#27542;&#31278;&#23376;&#12398;NIR&#28204;&#23450;&#32080;&#26524;&#65288;NIR+&#12501;&#12451;&#12540;&#12523;&#12489;&#65289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087011\Desktop\Density\H3911&#33258;&#27542;&#31278;&#23376;&#12398;NIR&#28204;&#23450;&#32080;&#26524;&#65288;NIR+&#12501;&#12451;&#12540;&#12523;&#12489;&#65289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087011\Desktop\Density\H3911&#33258;&#27542;&#31278;&#23376;&#12398;NIR&#28204;&#23450;&#32080;&#26524;&#65288;NIR+&#12501;&#12451;&#12540;&#12523;&#12489;&#65289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087011\Desktop\Density\H3911&#33258;&#27542;&#31278;&#23376;&#12398;NIR&#28204;&#23450;&#32080;&#26524;&#65288;NIR+&#12501;&#12451;&#12540;&#12523;&#12489;&#6528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050" b="1" i="0" u="none" strike="noStrike" kern="1200" spc="0" baseline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defRPr>
            </a:pPr>
            <a:r>
              <a:rPr lang="en-US" altLang="ja-JP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A)</a:t>
            </a:r>
            <a:r>
              <a:rPr lang="ja-JP" altLang="en-US" sz="1050" b="1" baseline="0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WBD vs  Wood Vol.</a:t>
            </a:r>
            <a:endParaRPr lang="ja-JP" altLang="en-US" sz="1050" b="1" dirty="0">
              <a:solidFill>
                <a:schemeClr val="tx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c:rich>
      </c:tx>
      <c:layout>
        <c:manualLayout>
          <c:xMode val="edge"/>
          <c:yMode val="edge"/>
          <c:x val="0.32638352683035221"/>
          <c:y val="8.4588232026506865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4462038940117764"/>
          <c:y val="0.20381027925001796"/>
          <c:w val="0.67671890623264086"/>
          <c:h val="0.56339124084252079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8696464281746472"/>
                  <c:y val="-0.3050151290379500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7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◎高容積重データ (NIR+フィールド)'!$G$3:$G$99</c:f>
              <c:numCache>
                <c:formatCode>General</c:formatCode>
                <c:ptCount val="97"/>
                <c:pt idx="0">
                  <c:v>367.40683333333345</c:v>
                </c:pt>
                <c:pt idx="1">
                  <c:v>377.79900000000009</c:v>
                </c:pt>
                <c:pt idx="2">
                  <c:v>389.54666666666674</c:v>
                </c:pt>
                <c:pt idx="3">
                  <c:v>398.58333333333337</c:v>
                </c:pt>
                <c:pt idx="4">
                  <c:v>408.52366666666666</c:v>
                </c:pt>
                <c:pt idx="5">
                  <c:v>416.20483333333345</c:v>
                </c:pt>
                <c:pt idx="6">
                  <c:v>421.17500000000001</c:v>
                </c:pt>
                <c:pt idx="7">
                  <c:v>422.98233333333337</c:v>
                </c:pt>
                <c:pt idx="8">
                  <c:v>436.53733333333338</c:v>
                </c:pt>
                <c:pt idx="9">
                  <c:v>440.1520000000001</c:v>
                </c:pt>
                <c:pt idx="10">
                  <c:v>460.48450000000008</c:v>
                </c:pt>
                <c:pt idx="11">
                  <c:v>463.64733333333339</c:v>
                </c:pt>
                <c:pt idx="12">
                  <c:v>464.55100000000004</c:v>
                </c:pt>
                <c:pt idx="13">
                  <c:v>466.81016666666676</c:v>
                </c:pt>
                <c:pt idx="14">
                  <c:v>474.03950000000009</c:v>
                </c:pt>
                <c:pt idx="15">
                  <c:v>475.3950000000001</c:v>
                </c:pt>
                <c:pt idx="16">
                  <c:v>477.2023333333334</c:v>
                </c:pt>
                <c:pt idx="17">
                  <c:v>477.2023333333334</c:v>
                </c:pt>
                <c:pt idx="18">
                  <c:v>478.55783333333346</c:v>
                </c:pt>
                <c:pt idx="19">
                  <c:v>479.00966666666676</c:v>
                </c:pt>
                <c:pt idx="20">
                  <c:v>479.91333333333347</c:v>
                </c:pt>
                <c:pt idx="21">
                  <c:v>483.97983333333349</c:v>
                </c:pt>
                <c:pt idx="22">
                  <c:v>486.23899999999998</c:v>
                </c:pt>
                <c:pt idx="23">
                  <c:v>487.5945000000001</c:v>
                </c:pt>
                <c:pt idx="24">
                  <c:v>490.75733333333341</c:v>
                </c:pt>
                <c:pt idx="25">
                  <c:v>491.661</c:v>
                </c:pt>
                <c:pt idx="26">
                  <c:v>493.46833333333342</c:v>
                </c:pt>
                <c:pt idx="27">
                  <c:v>496.17933333333343</c:v>
                </c:pt>
                <c:pt idx="28">
                  <c:v>497.98666666666674</c:v>
                </c:pt>
                <c:pt idx="29">
                  <c:v>498.43850000000015</c:v>
                </c:pt>
                <c:pt idx="30">
                  <c:v>499.79400000000004</c:v>
                </c:pt>
                <c:pt idx="31">
                  <c:v>502.95683333333335</c:v>
                </c:pt>
                <c:pt idx="32">
                  <c:v>505.66783333333336</c:v>
                </c:pt>
                <c:pt idx="33">
                  <c:v>506.11966666666666</c:v>
                </c:pt>
                <c:pt idx="34">
                  <c:v>506.57149999999996</c:v>
                </c:pt>
                <c:pt idx="35">
                  <c:v>506.57149999999996</c:v>
                </c:pt>
                <c:pt idx="36">
                  <c:v>507.02333333333348</c:v>
                </c:pt>
                <c:pt idx="37">
                  <c:v>510.63800000000009</c:v>
                </c:pt>
                <c:pt idx="38">
                  <c:v>511.18019999999996</c:v>
                </c:pt>
                <c:pt idx="39">
                  <c:v>511.54166666666669</c:v>
                </c:pt>
                <c:pt idx="40">
                  <c:v>511.99349999999998</c:v>
                </c:pt>
                <c:pt idx="41">
                  <c:v>511.99349999999998</c:v>
                </c:pt>
                <c:pt idx="42">
                  <c:v>512.89716666666675</c:v>
                </c:pt>
                <c:pt idx="43">
                  <c:v>514.25266666666664</c:v>
                </c:pt>
                <c:pt idx="44">
                  <c:v>514.25266666666664</c:v>
                </c:pt>
                <c:pt idx="45">
                  <c:v>519.67466666666667</c:v>
                </c:pt>
                <c:pt idx="46">
                  <c:v>521.48200000000008</c:v>
                </c:pt>
                <c:pt idx="47">
                  <c:v>522.38566666666668</c:v>
                </c:pt>
                <c:pt idx="48">
                  <c:v>524.64483333333339</c:v>
                </c:pt>
                <c:pt idx="49">
                  <c:v>526.00033333333329</c:v>
                </c:pt>
                <c:pt idx="50">
                  <c:v>526.90400000000011</c:v>
                </c:pt>
                <c:pt idx="51">
                  <c:v>527.35583333333341</c:v>
                </c:pt>
                <c:pt idx="52">
                  <c:v>528.7113333333333</c:v>
                </c:pt>
                <c:pt idx="53">
                  <c:v>529.61500000000001</c:v>
                </c:pt>
                <c:pt idx="54">
                  <c:v>531.42233333333331</c:v>
                </c:pt>
                <c:pt idx="55">
                  <c:v>532.32600000000002</c:v>
                </c:pt>
                <c:pt idx="56">
                  <c:v>535.94066666666674</c:v>
                </c:pt>
                <c:pt idx="57">
                  <c:v>536.39250000000004</c:v>
                </c:pt>
                <c:pt idx="58">
                  <c:v>537.29616666666664</c:v>
                </c:pt>
                <c:pt idx="59">
                  <c:v>537.74800000000005</c:v>
                </c:pt>
                <c:pt idx="60">
                  <c:v>540.91083333333324</c:v>
                </c:pt>
                <c:pt idx="61">
                  <c:v>541.36266666666677</c:v>
                </c:pt>
                <c:pt idx="62">
                  <c:v>541.81450000000007</c:v>
                </c:pt>
                <c:pt idx="63">
                  <c:v>544.07366666666655</c:v>
                </c:pt>
                <c:pt idx="64">
                  <c:v>544.97733333333338</c:v>
                </c:pt>
                <c:pt idx="65">
                  <c:v>545.88099999999997</c:v>
                </c:pt>
                <c:pt idx="66">
                  <c:v>546.78466666666668</c:v>
                </c:pt>
                <c:pt idx="67">
                  <c:v>547.23649999999998</c:v>
                </c:pt>
                <c:pt idx="68">
                  <c:v>547.23649999999998</c:v>
                </c:pt>
                <c:pt idx="69">
                  <c:v>548.59199999999998</c:v>
                </c:pt>
                <c:pt idx="70">
                  <c:v>548.59199999999998</c:v>
                </c:pt>
                <c:pt idx="71">
                  <c:v>549.49566666666658</c:v>
                </c:pt>
                <c:pt idx="72">
                  <c:v>550.3993333333334</c:v>
                </c:pt>
                <c:pt idx="73">
                  <c:v>551.75483333333329</c:v>
                </c:pt>
                <c:pt idx="74">
                  <c:v>552.6585</c:v>
                </c:pt>
                <c:pt idx="75">
                  <c:v>553.56216666666671</c:v>
                </c:pt>
                <c:pt idx="76">
                  <c:v>554.46583333333331</c:v>
                </c:pt>
                <c:pt idx="77">
                  <c:v>554.91766666666661</c:v>
                </c:pt>
                <c:pt idx="78">
                  <c:v>554.91766666666672</c:v>
                </c:pt>
                <c:pt idx="79">
                  <c:v>554.91766666666672</c:v>
                </c:pt>
                <c:pt idx="80">
                  <c:v>555.82133333333331</c:v>
                </c:pt>
                <c:pt idx="81">
                  <c:v>557.62866666666673</c:v>
                </c:pt>
                <c:pt idx="82">
                  <c:v>558.08050000000003</c:v>
                </c:pt>
                <c:pt idx="83">
                  <c:v>559.43600000000004</c:v>
                </c:pt>
                <c:pt idx="84">
                  <c:v>562.59883333333335</c:v>
                </c:pt>
                <c:pt idx="85">
                  <c:v>563.05066666666664</c:v>
                </c:pt>
                <c:pt idx="86">
                  <c:v>564.85800000000006</c:v>
                </c:pt>
                <c:pt idx="87">
                  <c:v>568.02083333333337</c:v>
                </c:pt>
                <c:pt idx="88">
                  <c:v>570.28</c:v>
                </c:pt>
                <c:pt idx="89">
                  <c:v>578.86483333333342</c:v>
                </c:pt>
                <c:pt idx="90">
                  <c:v>583.83500000000004</c:v>
                </c:pt>
                <c:pt idx="91">
                  <c:v>585.64233333333334</c:v>
                </c:pt>
                <c:pt idx="92">
                  <c:v>588.35333333333335</c:v>
                </c:pt>
                <c:pt idx="93">
                  <c:v>591.06433333333337</c:v>
                </c:pt>
                <c:pt idx="94">
                  <c:v>594.22716666666668</c:v>
                </c:pt>
                <c:pt idx="95">
                  <c:v>599.1973333333334</c:v>
                </c:pt>
                <c:pt idx="96">
                  <c:v>609.43888888888887</c:v>
                </c:pt>
              </c:numCache>
            </c:numRef>
          </c:xVal>
          <c:yVal>
            <c:numRef>
              <c:f>'◎高容積重データ (NIR+フィールド)'!$F$3:$F$99</c:f>
              <c:numCache>
                <c:formatCode>General</c:formatCode>
                <c:ptCount val="97"/>
                <c:pt idx="0">
                  <c:v>1.6964600329384884E-2</c:v>
                </c:pt>
                <c:pt idx="1">
                  <c:v>0.10459241589743427</c:v>
                </c:pt>
                <c:pt idx="2">
                  <c:v>3.0841643398821721E-2</c:v>
                </c:pt>
                <c:pt idx="3">
                  <c:v>2.8233618841517611E-2</c:v>
                </c:pt>
                <c:pt idx="4">
                  <c:v>1.0833782265904403E-2</c:v>
                </c:pt>
                <c:pt idx="5">
                  <c:v>9.3397287644513965E-3</c:v>
                </c:pt>
                <c:pt idx="6">
                  <c:v>5.7300727346773848E-2</c:v>
                </c:pt>
                <c:pt idx="7">
                  <c:v>1.0703531834486571E-2</c:v>
                </c:pt>
                <c:pt idx="8">
                  <c:v>9.6933841326513059E-3</c:v>
                </c:pt>
                <c:pt idx="9">
                  <c:v>1.0758421741330092E-2</c:v>
                </c:pt>
                <c:pt idx="10">
                  <c:v>3.0963788521193292E-2</c:v>
                </c:pt>
                <c:pt idx="11">
                  <c:v>2.7746546316505052E-2</c:v>
                </c:pt>
                <c:pt idx="12">
                  <c:v>0.11889357397510571</c:v>
                </c:pt>
                <c:pt idx="13">
                  <c:v>8.7829128825291411E-2</c:v>
                </c:pt>
                <c:pt idx="14">
                  <c:v>9.719302272043423E-2</c:v>
                </c:pt>
                <c:pt idx="15">
                  <c:v>5.7932225169257223E-2</c:v>
                </c:pt>
                <c:pt idx="16">
                  <c:v>3.1651872710553149E-2</c:v>
                </c:pt>
                <c:pt idx="17">
                  <c:v>1.5332228786579628E-2</c:v>
                </c:pt>
                <c:pt idx="18">
                  <c:v>1.529034507332197E-2</c:v>
                </c:pt>
                <c:pt idx="19">
                  <c:v>3.7652063351497372E-2</c:v>
                </c:pt>
                <c:pt idx="20">
                  <c:v>7.2925048851913643E-2</c:v>
                </c:pt>
                <c:pt idx="21">
                  <c:v>2.1058723875543101E-2</c:v>
                </c:pt>
                <c:pt idx="22">
                  <c:v>4.3550014001123155E-2</c:v>
                </c:pt>
                <c:pt idx="23">
                  <c:v>6.4314081618500774E-2</c:v>
                </c:pt>
                <c:pt idx="24">
                  <c:v>1.560743230303409E-2</c:v>
                </c:pt>
                <c:pt idx="25">
                  <c:v>5.0694938173182415E-2</c:v>
                </c:pt>
                <c:pt idx="26">
                  <c:v>0.1240358836269489</c:v>
                </c:pt>
                <c:pt idx="27">
                  <c:v>1.4813149715612293E-2</c:v>
                </c:pt>
                <c:pt idx="28">
                  <c:v>2.2338533324391899E-2</c:v>
                </c:pt>
                <c:pt idx="29">
                  <c:v>2.521075325749229E-2</c:v>
                </c:pt>
                <c:pt idx="30">
                  <c:v>4.6952358844960893E-2</c:v>
                </c:pt>
                <c:pt idx="31">
                  <c:v>3.8477523104413373E-2</c:v>
                </c:pt>
                <c:pt idx="32">
                  <c:v>2.6116813711528814E-2</c:v>
                </c:pt>
                <c:pt idx="33">
                  <c:v>2.1615765952136417E-2</c:v>
                </c:pt>
                <c:pt idx="34">
                  <c:v>1.3911877048779837E-2</c:v>
                </c:pt>
                <c:pt idx="35">
                  <c:v>1.7242819774786797E-2</c:v>
                </c:pt>
                <c:pt idx="36">
                  <c:v>2.9676740842870621E-2</c:v>
                </c:pt>
                <c:pt idx="37">
                  <c:v>3.5727448293684565E-2</c:v>
                </c:pt>
                <c:pt idx="38">
                  <c:v>3.5410474161307964E-2</c:v>
                </c:pt>
                <c:pt idx="39">
                  <c:v>3.1102558951887665E-2</c:v>
                </c:pt>
                <c:pt idx="40">
                  <c:v>4.1660308320877054E-2</c:v>
                </c:pt>
                <c:pt idx="41">
                  <c:v>7.8738364995451712E-2</c:v>
                </c:pt>
                <c:pt idx="42">
                  <c:v>3.8521517967934266E-2</c:v>
                </c:pt>
                <c:pt idx="43">
                  <c:v>2.5845606300929719E-2</c:v>
                </c:pt>
                <c:pt idx="44">
                  <c:v>5.1270792106585431E-2</c:v>
                </c:pt>
                <c:pt idx="45">
                  <c:v>2.5229753609861204E-2</c:v>
                </c:pt>
                <c:pt idx="46">
                  <c:v>5.2462687226616192E-2</c:v>
                </c:pt>
                <c:pt idx="47">
                  <c:v>8.1267032922326135E-2</c:v>
                </c:pt>
                <c:pt idx="48">
                  <c:v>3.5234947096566611E-2</c:v>
                </c:pt>
                <c:pt idx="49">
                  <c:v>2.7663005084660804E-2</c:v>
                </c:pt>
                <c:pt idx="50">
                  <c:v>5.6526048297510428E-2</c:v>
                </c:pt>
                <c:pt idx="51">
                  <c:v>2.736050741123194E-2</c:v>
                </c:pt>
                <c:pt idx="52">
                  <c:v>5.5040703290893181E-2</c:v>
                </c:pt>
                <c:pt idx="53">
                  <c:v>3.7368566030437422E-2</c:v>
                </c:pt>
                <c:pt idx="54">
                  <c:v>5.7326777433057426E-2</c:v>
                </c:pt>
                <c:pt idx="55">
                  <c:v>3.1122577180276334E-2</c:v>
                </c:pt>
                <c:pt idx="56">
                  <c:v>1.4575645311000904E-2</c:v>
                </c:pt>
                <c:pt idx="57">
                  <c:v>6.126105674500097E-3</c:v>
                </c:pt>
                <c:pt idx="58">
                  <c:v>1.8370626404684304E-2</c:v>
                </c:pt>
                <c:pt idx="59">
                  <c:v>1.4813149715612293E-2</c:v>
                </c:pt>
                <c:pt idx="60">
                  <c:v>9.1461513649595649E-2</c:v>
                </c:pt>
                <c:pt idx="61">
                  <c:v>3.3295855579806063E-2</c:v>
                </c:pt>
                <c:pt idx="62">
                  <c:v>3.6099576226687587E-2</c:v>
                </c:pt>
                <c:pt idx="63">
                  <c:v>8.358948670741894E-3</c:v>
                </c:pt>
                <c:pt idx="64">
                  <c:v>2.9504380503524077E-2</c:v>
                </c:pt>
                <c:pt idx="65">
                  <c:v>1.9123138376183978E-2</c:v>
                </c:pt>
                <c:pt idx="66">
                  <c:v>6.6808481052709826E-2</c:v>
                </c:pt>
                <c:pt idx="67">
                  <c:v>4.9385836514431555E-2</c:v>
                </c:pt>
                <c:pt idx="68">
                  <c:v>8.1680139789902587E-2</c:v>
                </c:pt>
                <c:pt idx="69">
                  <c:v>4.5931655391809573E-2</c:v>
                </c:pt>
                <c:pt idx="70">
                  <c:v>4.1800172025814875E-2</c:v>
                </c:pt>
                <c:pt idx="71">
                  <c:v>6.8989977858621362E-2</c:v>
                </c:pt>
                <c:pt idx="72">
                  <c:v>1.5711180258826247E-2</c:v>
                </c:pt>
                <c:pt idx="73">
                  <c:v>5.6481714141982983E-2</c:v>
                </c:pt>
                <c:pt idx="74">
                  <c:v>1.9377645080236591E-2</c:v>
                </c:pt>
                <c:pt idx="75">
                  <c:v>0.17299274194771805</c:v>
                </c:pt>
                <c:pt idx="76">
                  <c:v>3.5324972575647873E-2</c:v>
                </c:pt>
                <c:pt idx="77">
                  <c:v>4.9674234720031095E-2</c:v>
                </c:pt>
                <c:pt idx="78">
                  <c:v>4.5974406184639632E-2</c:v>
                </c:pt>
                <c:pt idx="79">
                  <c:v>6.3991980406913507E-2</c:v>
                </c:pt>
                <c:pt idx="80">
                  <c:v>9.7239392628001201E-2</c:v>
                </c:pt>
                <c:pt idx="81">
                  <c:v>6.7351159767690932E-2</c:v>
                </c:pt>
                <c:pt idx="82">
                  <c:v>5.8844543675859701E-2</c:v>
                </c:pt>
                <c:pt idx="83">
                  <c:v>2.1179285635217267E-2</c:v>
                </c:pt>
                <c:pt idx="84">
                  <c:v>9.1343176137520216E-2</c:v>
                </c:pt>
                <c:pt idx="85">
                  <c:v>4.551398693170014E-2</c:v>
                </c:pt>
                <c:pt idx="86">
                  <c:v>6.4774613968775804E-2</c:v>
                </c:pt>
                <c:pt idx="87">
                  <c:v>3.4220991784435197E-2</c:v>
                </c:pt>
                <c:pt idx="88">
                  <c:v>3.8475713547044918E-2</c:v>
                </c:pt>
                <c:pt idx="89">
                  <c:v>2.3245875548231092E-2</c:v>
                </c:pt>
                <c:pt idx="90">
                  <c:v>2.5177351844399318E-2</c:v>
                </c:pt>
                <c:pt idx="91">
                  <c:v>4.6467133576428662E-2</c:v>
                </c:pt>
                <c:pt idx="92">
                  <c:v>8.2570102723182104E-2</c:v>
                </c:pt>
                <c:pt idx="93">
                  <c:v>1.0314477000266008E-2</c:v>
                </c:pt>
                <c:pt idx="94">
                  <c:v>5.9841157396543304E-2</c:v>
                </c:pt>
                <c:pt idx="95">
                  <c:v>0.15712748541878915</c:v>
                </c:pt>
                <c:pt idx="96">
                  <c:v>0.1411020453636390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BD9-42CB-BF3F-7B0EBA653E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746688"/>
        <c:axId val="53997952"/>
      </c:scatterChart>
      <c:valAx>
        <c:axId val="53746688"/>
        <c:scaling>
          <c:orientation val="minMax"/>
          <c:min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ja-JP" sz="90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WBD (kg/m</a:t>
                </a:r>
                <a:r>
                  <a:rPr lang="en-US" altLang="en-US" sz="900" baseline="300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3</a:t>
                </a: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997952"/>
        <c:crosses val="autoZero"/>
        <c:crossBetween val="midCat"/>
      </c:valAx>
      <c:valAx>
        <c:axId val="53997952"/>
        <c:scaling>
          <c:orientation val="minMax"/>
          <c:max val="0.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lang="ja-JP" sz="105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105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Wood Vol. (m3)</a:t>
                </a:r>
              </a:p>
            </c:rich>
          </c:tx>
          <c:layout/>
          <c:overlay val="0"/>
        </c:title>
        <c:numFmt formatCode="#,##0.00_);[Red]\(#,##0.0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746688"/>
        <c:crosses val="autoZero"/>
        <c:crossBetween val="midCat"/>
        <c:majorUnit val="4.0000000000000008E-2"/>
      </c:valAx>
      <c:spPr>
        <a:noFill/>
        <a:ln w="19050"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050" b="1" i="0" u="none" strike="noStrike" kern="1200" spc="0" baseline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defRPr>
            </a:pPr>
            <a:r>
              <a:rPr lang="en-US" altLang="ja-JP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B)  WBD </a:t>
            </a:r>
            <a:r>
              <a:rPr lang="en-US" altLang="ja-JP" sz="1050" b="1" dirty="0" err="1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vs</a:t>
            </a:r>
            <a:r>
              <a:rPr lang="en-US" altLang="ja-JP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050" b="1" dirty="0">
                <a:solidFill>
                  <a:schemeClr val="tx1"/>
                </a:solidFill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a</a:t>
            </a:r>
            <a:r>
              <a:rPr lang="en-US" altLang="ja-JP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cellulose</a:t>
            </a:r>
            <a:endParaRPr lang="ja-JP" altLang="en-US" sz="1050" b="1" dirty="0">
              <a:solidFill>
                <a:schemeClr val="tx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c:rich>
      </c:tx>
      <c:layout>
        <c:manualLayout>
          <c:xMode val="edge"/>
          <c:yMode val="edge"/>
          <c:x val="0.29942850512416008"/>
          <c:y val="9.153145911424094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0656488843150408"/>
          <c:y val="0.20821738425412528"/>
          <c:w val="0.65315357706275989"/>
          <c:h val="0.55655598864995859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3437263570684332"/>
                  <c:y val="-0.2047055209937780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7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en-US" baseline="0" dirty="0"/>
                      <a:t>y = 0.0049x + 49.749
R² = 0.0060</a:t>
                    </a:r>
                    <a:endParaRPr lang="en-US" altLang="en-US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</c:trendlineLbl>
          </c:trendline>
          <c:xVal>
            <c:numRef>
              <c:f>'◎高容積重データ (NIR+フィールド)'!$G$3:$G$99</c:f>
              <c:numCache>
                <c:formatCode>General</c:formatCode>
                <c:ptCount val="97"/>
                <c:pt idx="0">
                  <c:v>367.40683333333345</c:v>
                </c:pt>
                <c:pt idx="1">
                  <c:v>377.79900000000009</c:v>
                </c:pt>
                <c:pt idx="2">
                  <c:v>389.54666666666674</c:v>
                </c:pt>
                <c:pt idx="3">
                  <c:v>398.58333333333337</c:v>
                </c:pt>
                <c:pt idx="4">
                  <c:v>408.52366666666666</c:v>
                </c:pt>
                <c:pt idx="5">
                  <c:v>416.20483333333345</c:v>
                </c:pt>
                <c:pt idx="6">
                  <c:v>421.17500000000001</c:v>
                </c:pt>
                <c:pt idx="7">
                  <c:v>422.98233333333337</c:v>
                </c:pt>
                <c:pt idx="8">
                  <c:v>436.53733333333338</c:v>
                </c:pt>
                <c:pt idx="9">
                  <c:v>440.1520000000001</c:v>
                </c:pt>
                <c:pt idx="10">
                  <c:v>460.48450000000008</c:v>
                </c:pt>
                <c:pt idx="11">
                  <c:v>463.64733333333339</c:v>
                </c:pt>
                <c:pt idx="12">
                  <c:v>464.55100000000004</c:v>
                </c:pt>
                <c:pt idx="13">
                  <c:v>466.81016666666676</c:v>
                </c:pt>
                <c:pt idx="14">
                  <c:v>474.03950000000009</c:v>
                </c:pt>
                <c:pt idx="15">
                  <c:v>475.3950000000001</c:v>
                </c:pt>
                <c:pt idx="16">
                  <c:v>477.2023333333334</c:v>
                </c:pt>
                <c:pt idx="17">
                  <c:v>477.2023333333334</c:v>
                </c:pt>
                <c:pt idx="18">
                  <c:v>478.55783333333346</c:v>
                </c:pt>
                <c:pt idx="19">
                  <c:v>479.00966666666676</c:v>
                </c:pt>
                <c:pt idx="20">
                  <c:v>479.91333333333347</c:v>
                </c:pt>
                <c:pt idx="21">
                  <c:v>483.97983333333349</c:v>
                </c:pt>
                <c:pt idx="22">
                  <c:v>486.23899999999998</c:v>
                </c:pt>
                <c:pt idx="23">
                  <c:v>487.5945000000001</c:v>
                </c:pt>
                <c:pt idx="24">
                  <c:v>490.75733333333341</c:v>
                </c:pt>
                <c:pt idx="25">
                  <c:v>491.661</c:v>
                </c:pt>
                <c:pt idx="26">
                  <c:v>493.46833333333342</c:v>
                </c:pt>
                <c:pt idx="27">
                  <c:v>496.17933333333343</c:v>
                </c:pt>
                <c:pt idx="28">
                  <c:v>497.98666666666674</c:v>
                </c:pt>
                <c:pt idx="29">
                  <c:v>498.43850000000015</c:v>
                </c:pt>
                <c:pt idx="30">
                  <c:v>499.79400000000004</c:v>
                </c:pt>
                <c:pt idx="31">
                  <c:v>502.95683333333335</c:v>
                </c:pt>
                <c:pt idx="32">
                  <c:v>505.66783333333336</c:v>
                </c:pt>
                <c:pt idx="33">
                  <c:v>506.11966666666666</c:v>
                </c:pt>
                <c:pt idx="34">
                  <c:v>506.57149999999996</c:v>
                </c:pt>
                <c:pt idx="35">
                  <c:v>506.57149999999996</c:v>
                </c:pt>
                <c:pt idx="36">
                  <c:v>507.02333333333348</c:v>
                </c:pt>
                <c:pt idx="37">
                  <c:v>510.63800000000009</c:v>
                </c:pt>
                <c:pt idx="38">
                  <c:v>511.18019999999996</c:v>
                </c:pt>
                <c:pt idx="39">
                  <c:v>511.54166666666669</c:v>
                </c:pt>
                <c:pt idx="40">
                  <c:v>511.99349999999998</c:v>
                </c:pt>
                <c:pt idx="41">
                  <c:v>511.99349999999998</c:v>
                </c:pt>
                <c:pt idx="42">
                  <c:v>512.89716666666675</c:v>
                </c:pt>
                <c:pt idx="43">
                  <c:v>514.25266666666664</c:v>
                </c:pt>
                <c:pt idx="44">
                  <c:v>514.25266666666664</c:v>
                </c:pt>
                <c:pt idx="45">
                  <c:v>519.67466666666667</c:v>
                </c:pt>
                <c:pt idx="46">
                  <c:v>521.48200000000008</c:v>
                </c:pt>
                <c:pt idx="47">
                  <c:v>522.38566666666668</c:v>
                </c:pt>
                <c:pt idx="48">
                  <c:v>524.64483333333339</c:v>
                </c:pt>
                <c:pt idx="49">
                  <c:v>526.00033333333329</c:v>
                </c:pt>
                <c:pt idx="50">
                  <c:v>526.90400000000011</c:v>
                </c:pt>
                <c:pt idx="51">
                  <c:v>527.35583333333341</c:v>
                </c:pt>
                <c:pt idx="52">
                  <c:v>528.7113333333333</c:v>
                </c:pt>
                <c:pt idx="53">
                  <c:v>529.61500000000001</c:v>
                </c:pt>
                <c:pt idx="54">
                  <c:v>531.42233333333331</c:v>
                </c:pt>
                <c:pt idx="55">
                  <c:v>532.32600000000002</c:v>
                </c:pt>
                <c:pt idx="56">
                  <c:v>535.94066666666674</c:v>
                </c:pt>
                <c:pt idx="57">
                  <c:v>536.39250000000004</c:v>
                </c:pt>
                <c:pt idx="58">
                  <c:v>537.29616666666664</c:v>
                </c:pt>
                <c:pt idx="59">
                  <c:v>537.74800000000005</c:v>
                </c:pt>
                <c:pt idx="60">
                  <c:v>540.91083333333324</c:v>
                </c:pt>
                <c:pt idx="61">
                  <c:v>541.36266666666677</c:v>
                </c:pt>
                <c:pt idx="62">
                  <c:v>541.81450000000007</c:v>
                </c:pt>
                <c:pt idx="63">
                  <c:v>544.07366666666655</c:v>
                </c:pt>
                <c:pt idx="64">
                  <c:v>544.97733333333338</c:v>
                </c:pt>
                <c:pt idx="65">
                  <c:v>545.88099999999997</c:v>
                </c:pt>
                <c:pt idx="66">
                  <c:v>546.78466666666668</c:v>
                </c:pt>
                <c:pt idx="67">
                  <c:v>547.23649999999998</c:v>
                </c:pt>
                <c:pt idx="68">
                  <c:v>547.23649999999998</c:v>
                </c:pt>
                <c:pt idx="69">
                  <c:v>548.59199999999998</c:v>
                </c:pt>
                <c:pt idx="70">
                  <c:v>548.59199999999998</c:v>
                </c:pt>
                <c:pt idx="71">
                  <c:v>549.49566666666658</c:v>
                </c:pt>
                <c:pt idx="72">
                  <c:v>550.3993333333334</c:v>
                </c:pt>
                <c:pt idx="73">
                  <c:v>551.75483333333329</c:v>
                </c:pt>
                <c:pt idx="74">
                  <c:v>552.6585</c:v>
                </c:pt>
                <c:pt idx="75">
                  <c:v>553.56216666666671</c:v>
                </c:pt>
                <c:pt idx="76">
                  <c:v>554.46583333333331</c:v>
                </c:pt>
                <c:pt idx="77">
                  <c:v>554.91766666666661</c:v>
                </c:pt>
                <c:pt idx="78">
                  <c:v>554.91766666666672</c:v>
                </c:pt>
                <c:pt idx="79">
                  <c:v>554.91766666666672</c:v>
                </c:pt>
                <c:pt idx="80">
                  <c:v>555.82133333333331</c:v>
                </c:pt>
                <c:pt idx="81">
                  <c:v>557.62866666666673</c:v>
                </c:pt>
                <c:pt idx="82">
                  <c:v>558.08050000000003</c:v>
                </c:pt>
                <c:pt idx="83">
                  <c:v>559.43600000000004</c:v>
                </c:pt>
                <c:pt idx="84">
                  <c:v>562.59883333333335</c:v>
                </c:pt>
                <c:pt idx="85">
                  <c:v>563.05066666666664</c:v>
                </c:pt>
                <c:pt idx="86">
                  <c:v>564.85800000000006</c:v>
                </c:pt>
                <c:pt idx="87">
                  <c:v>568.02083333333337</c:v>
                </c:pt>
                <c:pt idx="88">
                  <c:v>570.28</c:v>
                </c:pt>
                <c:pt idx="89">
                  <c:v>578.86483333333342</c:v>
                </c:pt>
                <c:pt idx="90">
                  <c:v>583.83500000000004</c:v>
                </c:pt>
                <c:pt idx="91">
                  <c:v>585.64233333333334</c:v>
                </c:pt>
                <c:pt idx="92">
                  <c:v>588.35333333333335</c:v>
                </c:pt>
                <c:pt idx="93">
                  <c:v>591.06433333333337</c:v>
                </c:pt>
                <c:pt idx="94">
                  <c:v>594.22716666666668</c:v>
                </c:pt>
                <c:pt idx="95">
                  <c:v>599.1973333333334</c:v>
                </c:pt>
                <c:pt idx="96">
                  <c:v>609.43888888888887</c:v>
                </c:pt>
              </c:numCache>
            </c:numRef>
          </c:xVal>
          <c:yVal>
            <c:numRef>
              <c:f>'◎高容積重データ (NIR+フィールド)'!$R$3:$R$99</c:f>
              <c:numCache>
                <c:formatCode>0.0000_ </c:formatCode>
                <c:ptCount val="97"/>
                <c:pt idx="0">
                  <c:v>57.839874999999999</c:v>
                </c:pt>
                <c:pt idx="1">
                  <c:v>50.747399999999999</c:v>
                </c:pt>
                <c:pt idx="2">
                  <c:v>48.106618750000003</c:v>
                </c:pt>
                <c:pt idx="3">
                  <c:v>54.771299999999997</c:v>
                </c:pt>
                <c:pt idx="4">
                  <c:v>51.204899999999995</c:v>
                </c:pt>
                <c:pt idx="5">
                  <c:v>51.957975000000005</c:v>
                </c:pt>
                <c:pt idx="6">
                  <c:v>45.797600000000003</c:v>
                </c:pt>
                <c:pt idx="7">
                  <c:v>45.336075000000008</c:v>
                </c:pt>
                <c:pt idx="8">
                  <c:v>54.006174999999999</c:v>
                </c:pt>
                <c:pt idx="9">
                  <c:v>55.602649999999997</c:v>
                </c:pt>
                <c:pt idx="10">
                  <c:v>50.451900000000002</c:v>
                </c:pt>
                <c:pt idx="11">
                  <c:v>50.460975000000005</c:v>
                </c:pt>
                <c:pt idx="12">
                  <c:v>51.423400000000001</c:v>
                </c:pt>
                <c:pt idx="13">
                  <c:v>52.930799999999998</c:v>
                </c:pt>
                <c:pt idx="14">
                  <c:v>51.658575000000006</c:v>
                </c:pt>
                <c:pt idx="15">
                  <c:v>49.436974999999997</c:v>
                </c:pt>
                <c:pt idx="16">
                  <c:v>54.82855</c:v>
                </c:pt>
                <c:pt idx="17">
                  <c:v>46.560724999999998</c:v>
                </c:pt>
                <c:pt idx="18">
                  <c:v>53.223525000000002</c:v>
                </c:pt>
                <c:pt idx="19">
                  <c:v>57.765375000000006</c:v>
                </c:pt>
                <c:pt idx="20">
                  <c:v>51.673874999999995</c:v>
                </c:pt>
                <c:pt idx="21">
                  <c:v>54.517400000000009</c:v>
                </c:pt>
                <c:pt idx="22">
                  <c:v>49.831891666666664</c:v>
                </c:pt>
                <c:pt idx="23">
                  <c:v>46.704656249999992</c:v>
                </c:pt>
                <c:pt idx="24">
                  <c:v>52.175449999999998</c:v>
                </c:pt>
                <c:pt idx="25">
                  <c:v>47.151975</c:v>
                </c:pt>
                <c:pt idx="26">
                  <c:v>53.681825000000003</c:v>
                </c:pt>
                <c:pt idx="27">
                  <c:v>51.617674999999998</c:v>
                </c:pt>
                <c:pt idx="28">
                  <c:v>56.074950000000001</c:v>
                </c:pt>
                <c:pt idx="29">
                  <c:v>47.450500000000005</c:v>
                </c:pt>
                <c:pt idx="30">
                  <c:v>50.504125000000002</c:v>
                </c:pt>
                <c:pt idx="31">
                  <c:v>56.287424999999999</c:v>
                </c:pt>
                <c:pt idx="32">
                  <c:v>53.0805875</c:v>
                </c:pt>
                <c:pt idx="33">
                  <c:v>49.299518749999997</c:v>
                </c:pt>
                <c:pt idx="34">
                  <c:v>54.447175000000001</c:v>
                </c:pt>
                <c:pt idx="35">
                  <c:v>50.747500000000002</c:v>
                </c:pt>
                <c:pt idx="36">
                  <c:v>49.443374999999996</c:v>
                </c:pt>
                <c:pt idx="37">
                  <c:v>53.099624999999996</c:v>
                </c:pt>
                <c:pt idx="38">
                  <c:v>56.374850000000002</c:v>
                </c:pt>
                <c:pt idx="39">
                  <c:v>49.937775000000002</c:v>
                </c:pt>
                <c:pt idx="40">
                  <c:v>52.020625000000003</c:v>
                </c:pt>
                <c:pt idx="41">
                  <c:v>52.499975000000006</c:v>
                </c:pt>
                <c:pt idx="42">
                  <c:v>57.007450000000006</c:v>
                </c:pt>
                <c:pt idx="43">
                  <c:v>53.220975000000003</c:v>
                </c:pt>
                <c:pt idx="44">
                  <c:v>57.952799999999996</c:v>
                </c:pt>
                <c:pt idx="45">
                  <c:v>52.760674999999999</c:v>
                </c:pt>
                <c:pt idx="46">
                  <c:v>54.840275000000005</c:v>
                </c:pt>
                <c:pt idx="47">
                  <c:v>53.247324999999996</c:v>
                </c:pt>
                <c:pt idx="48">
                  <c:v>52.320606249999997</c:v>
                </c:pt>
                <c:pt idx="49">
                  <c:v>56.830725000000001</c:v>
                </c:pt>
                <c:pt idx="50">
                  <c:v>50.646150000000006</c:v>
                </c:pt>
                <c:pt idx="51">
                  <c:v>57.107399999999998</c:v>
                </c:pt>
                <c:pt idx="52">
                  <c:v>51.688725000000005</c:v>
                </c:pt>
                <c:pt idx="53">
                  <c:v>53.628399999999999</c:v>
                </c:pt>
                <c:pt idx="54">
                  <c:v>53.280999999999999</c:v>
                </c:pt>
                <c:pt idx="55">
                  <c:v>47.846031250000003</c:v>
                </c:pt>
                <c:pt idx="56">
                  <c:v>49.999600000000001</c:v>
                </c:pt>
                <c:pt idx="57">
                  <c:v>54.606337499999995</c:v>
                </c:pt>
                <c:pt idx="58">
                  <c:v>50.950199999999995</c:v>
                </c:pt>
                <c:pt idx="59">
                  <c:v>45.534737499999991</c:v>
                </c:pt>
                <c:pt idx="60">
                  <c:v>56.641074999999994</c:v>
                </c:pt>
                <c:pt idx="61">
                  <c:v>55.969274999999996</c:v>
                </c:pt>
                <c:pt idx="62">
                  <c:v>54.936700000000002</c:v>
                </c:pt>
                <c:pt idx="63">
                  <c:v>51.070124999999997</c:v>
                </c:pt>
                <c:pt idx="64">
                  <c:v>53.843499999999999</c:v>
                </c:pt>
                <c:pt idx="65">
                  <c:v>44.569787500000004</c:v>
                </c:pt>
                <c:pt idx="66">
                  <c:v>49.356983333333332</c:v>
                </c:pt>
                <c:pt idx="67">
                  <c:v>49.679649999999995</c:v>
                </c:pt>
                <c:pt idx="68">
                  <c:v>53.864025000000005</c:v>
                </c:pt>
                <c:pt idx="69">
                  <c:v>50.370291666666667</c:v>
                </c:pt>
                <c:pt idx="70">
                  <c:v>46.865674999999996</c:v>
                </c:pt>
                <c:pt idx="71">
                  <c:v>51.908349999999999</c:v>
                </c:pt>
                <c:pt idx="72">
                  <c:v>52.069749999999992</c:v>
                </c:pt>
                <c:pt idx="73">
                  <c:v>56.019399999999997</c:v>
                </c:pt>
                <c:pt idx="74">
                  <c:v>57.334099999999992</c:v>
                </c:pt>
                <c:pt idx="75">
                  <c:v>52.087175000000002</c:v>
                </c:pt>
                <c:pt idx="76">
                  <c:v>54.439599999999999</c:v>
                </c:pt>
                <c:pt idx="77">
                  <c:v>49.779949999999999</c:v>
                </c:pt>
                <c:pt idx="78">
                  <c:v>51.772125000000003</c:v>
                </c:pt>
                <c:pt idx="79">
                  <c:v>53.703900000000004</c:v>
                </c:pt>
                <c:pt idx="80">
                  <c:v>52.672862500000001</c:v>
                </c:pt>
                <c:pt idx="81">
                  <c:v>48.895099999999999</c:v>
                </c:pt>
                <c:pt idx="82">
                  <c:v>54.887025000000001</c:v>
                </c:pt>
                <c:pt idx="83">
                  <c:v>55.489624999999997</c:v>
                </c:pt>
                <c:pt idx="84">
                  <c:v>54.723399999999998</c:v>
                </c:pt>
                <c:pt idx="85">
                  <c:v>54.368750000000006</c:v>
                </c:pt>
                <c:pt idx="86">
                  <c:v>53.441600000000001</c:v>
                </c:pt>
                <c:pt idx="87">
                  <c:v>56.022550000000003</c:v>
                </c:pt>
                <c:pt idx="88">
                  <c:v>55.903774999999996</c:v>
                </c:pt>
                <c:pt idx="89">
                  <c:v>52.420574999999999</c:v>
                </c:pt>
                <c:pt idx="90">
                  <c:v>53.793875</c:v>
                </c:pt>
                <c:pt idx="91">
                  <c:v>48.393187499999996</c:v>
                </c:pt>
                <c:pt idx="92">
                  <c:v>54.390575000000005</c:v>
                </c:pt>
                <c:pt idx="93">
                  <c:v>50.456775</c:v>
                </c:pt>
                <c:pt idx="94">
                  <c:v>46.966975000000005</c:v>
                </c:pt>
                <c:pt idx="95">
                  <c:v>53.341525000000004</c:v>
                </c:pt>
                <c:pt idx="96">
                  <c:v>50.19973124999999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09A-4FFF-8426-DD31B3E898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230656"/>
        <c:axId val="56328576"/>
      </c:scatterChart>
      <c:valAx>
        <c:axId val="56230656"/>
        <c:scaling>
          <c:orientation val="minMax"/>
          <c:min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ja-JP" sz="90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WBD (kg/m</a:t>
                </a:r>
                <a:r>
                  <a:rPr lang="en-US" altLang="en-US" sz="900" baseline="300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3</a:t>
                </a: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328576"/>
        <c:crosses val="autoZero"/>
        <c:crossBetween val="midCat"/>
      </c:valAx>
      <c:valAx>
        <c:axId val="56328576"/>
        <c:scaling>
          <c:orientation val="minMax"/>
          <c:max val="60"/>
          <c:min val="4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lang="ja-JP" sz="105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1400">
                    <a:latin typeface="Symbol" pitchFamily="18" charset="2"/>
                    <a:ea typeface="Arial Unicode MS" pitchFamily="50" charset="-128"/>
                    <a:cs typeface="Arial Unicode MS" pitchFamily="50" charset="-128"/>
                  </a:rPr>
                  <a:t>a</a:t>
                </a:r>
                <a:r>
                  <a:rPr lang="en-US" altLang="en-US" sz="105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-cellulose (%)</a:t>
                </a:r>
              </a:p>
            </c:rich>
          </c:tx>
          <c:layout/>
          <c:overlay val="0"/>
        </c:title>
        <c:numFmt formatCode="0_ 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230656"/>
        <c:crosses val="autoZero"/>
        <c:crossBetween val="midCat"/>
        <c:majorUnit val="4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1270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050" b="1" i="0" u="none" strike="noStrike" kern="1200" spc="0" baseline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defRPr>
            </a:pPr>
            <a:r>
              <a:rPr lang="en-US" altLang="en-US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C)  WBD </a:t>
            </a:r>
            <a:r>
              <a:rPr lang="en-US" altLang="en-US" sz="1050" b="1" dirty="0" err="1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vs</a:t>
            </a:r>
            <a:r>
              <a:rPr lang="en-US" altLang="en-US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en-US" sz="1050" b="1" dirty="0" err="1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lason</a:t>
            </a:r>
            <a:r>
              <a:rPr lang="en-US" altLang="en-US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lignin</a:t>
            </a:r>
          </a:p>
        </c:rich>
      </c:tx>
      <c:layout>
        <c:manualLayout>
          <c:xMode val="edge"/>
          <c:yMode val="edge"/>
          <c:x val="0.32112786079324523"/>
          <c:y val="9.027153548595612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4993368792356405"/>
          <c:y val="0.20464182430908351"/>
          <c:w val="0.67140560771025437"/>
          <c:h val="0.58222781643790422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2088587379180091"/>
                  <c:y val="-0.1797447589998417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7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◎高容積重データ (NIR+フィールド)'!$G$3:$G$99</c:f>
              <c:numCache>
                <c:formatCode>General</c:formatCode>
                <c:ptCount val="97"/>
                <c:pt idx="0">
                  <c:v>367.40683333333345</c:v>
                </c:pt>
                <c:pt idx="1">
                  <c:v>377.79900000000009</c:v>
                </c:pt>
                <c:pt idx="2">
                  <c:v>389.54666666666674</c:v>
                </c:pt>
                <c:pt idx="3">
                  <c:v>398.58333333333337</c:v>
                </c:pt>
                <c:pt idx="4">
                  <c:v>408.52366666666666</c:v>
                </c:pt>
                <c:pt idx="5">
                  <c:v>416.20483333333345</c:v>
                </c:pt>
                <c:pt idx="6">
                  <c:v>421.17500000000001</c:v>
                </c:pt>
                <c:pt idx="7">
                  <c:v>422.98233333333337</c:v>
                </c:pt>
                <c:pt idx="8">
                  <c:v>436.53733333333338</c:v>
                </c:pt>
                <c:pt idx="9">
                  <c:v>440.1520000000001</c:v>
                </c:pt>
                <c:pt idx="10">
                  <c:v>460.48450000000008</c:v>
                </c:pt>
                <c:pt idx="11">
                  <c:v>463.64733333333339</c:v>
                </c:pt>
                <c:pt idx="12">
                  <c:v>464.55100000000004</c:v>
                </c:pt>
                <c:pt idx="13">
                  <c:v>466.81016666666676</c:v>
                </c:pt>
                <c:pt idx="14">
                  <c:v>474.03950000000009</c:v>
                </c:pt>
                <c:pt idx="15">
                  <c:v>475.3950000000001</c:v>
                </c:pt>
                <c:pt idx="16">
                  <c:v>477.2023333333334</c:v>
                </c:pt>
                <c:pt idx="17">
                  <c:v>477.2023333333334</c:v>
                </c:pt>
                <c:pt idx="18">
                  <c:v>478.55783333333346</c:v>
                </c:pt>
                <c:pt idx="19">
                  <c:v>479.00966666666676</c:v>
                </c:pt>
                <c:pt idx="20">
                  <c:v>479.91333333333347</c:v>
                </c:pt>
                <c:pt idx="21">
                  <c:v>483.97983333333349</c:v>
                </c:pt>
                <c:pt idx="22">
                  <c:v>486.23899999999998</c:v>
                </c:pt>
                <c:pt idx="23">
                  <c:v>487.5945000000001</c:v>
                </c:pt>
                <c:pt idx="24">
                  <c:v>490.75733333333341</c:v>
                </c:pt>
                <c:pt idx="25">
                  <c:v>491.661</c:v>
                </c:pt>
                <c:pt idx="26">
                  <c:v>493.46833333333342</c:v>
                </c:pt>
                <c:pt idx="27">
                  <c:v>496.17933333333343</c:v>
                </c:pt>
                <c:pt idx="28">
                  <c:v>497.98666666666674</c:v>
                </c:pt>
                <c:pt idx="29">
                  <c:v>498.43850000000015</c:v>
                </c:pt>
                <c:pt idx="30">
                  <c:v>499.79400000000004</c:v>
                </c:pt>
                <c:pt idx="31">
                  <c:v>502.95683333333335</c:v>
                </c:pt>
                <c:pt idx="32">
                  <c:v>505.66783333333336</c:v>
                </c:pt>
                <c:pt idx="33">
                  <c:v>506.11966666666666</c:v>
                </c:pt>
                <c:pt idx="34">
                  <c:v>506.57149999999996</c:v>
                </c:pt>
                <c:pt idx="35">
                  <c:v>506.57149999999996</c:v>
                </c:pt>
                <c:pt idx="36">
                  <c:v>507.02333333333348</c:v>
                </c:pt>
                <c:pt idx="37">
                  <c:v>510.63800000000009</c:v>
                </c:pt>
                <c:pt idx="38">
                  <c:v>511.18019999999996</c:v>
                </c:pt>
                <c:pt idx="39">
                  <c:v>511.54166666666669</c:v>
                </c:pt>
                <c:pt idx="40">
                  <c:v>511.99349999999998</c:v>
                </c:pt>
                <c:pt idx="41">
                  <c:v>511.99349999999998</c:v>
                </c:pt>
                <c:pt idx="42">
                  <c:v>512.89716666666675</c:v>
                </c:pt>
                <c:pt idx="43">
                  <c:v>514.25266666666664</c:v>
                </c:pt>
                <c:pt idx="44">
                  <c:v>514.25266666666664</c:v>
                </c:pt>
                <c:pt idx="45">
                  <c:v>519.67466666666667</c:v>
                </c:pt>
                <c:pt idx="46">
                  <c:v>521.48200000000008</c:v>
                </c:pt>
                <c:pt idx="47">
                  <c:v>522.38566666666668</c:v>
                </c:pt>
                <c:pt idx="48">
                  <c:v>524.64483333333339</c:v>
                </c:pt>
                <c:pt idx="49">
                  <c:v>526.00033333333329</c:v>
                </c:pt>
                <c:pt idx="50">
                  <c:v>526.90400000000011</c:v>
                </c:pt>
                <c:pt idx="51">
                  <c:v>527.35583333333341</c:v>
                </c:pt>
                <c:pt idx="52">
                  <c:v>528.7113333333333</c:v>
                </c:pt>
                <c:pt idx="53">
                  <c:v>529.61500000000001</c:v>
                </c:pt>
                <c:pt idx="54">
                  <c:v>531.42233333333331</c:v>
                </c:pt>
                <c:pt idx="55">
                  <c:v>532.32600000000002</c:v>
                </c:pt>
                <c:pt idx="56">
                  <c:v>535.94066666666674</c:v>
                </c:pt>
                <c:pt idx="57">
                  <c:v>536.39250000000004</c:v>
                </c:pt>
                <c:pt idx="58">
                  <c:v>537.29616666666664</c:v>
                </c:pt>
                <c:pt idx="59">
                  <c:v>537.74800000000005</c:v>
                </c:pt>
                <c:pt idx="60">
                  <c:v>540.91083333333324</c:v>
                </c:pt>
                <c:pt idx="61">
                  <c:v>541.36266666666677</c:v>
                </c:pt>
                <c:pt idx="62">
                  <c:v>541.81450000000007</c:v>
                </c:pt>
                <c:pt idx="63">
                  <c:v>544.07366666666655</c:v>
                </c:pt>
                <c:pt idx="64">
                  <c:v>544.97733333333338</c:v>
                </c:pt>
                <c:pt idx="65">
                  <c:v>545.88099999999997</c:v>
                </c:pt>
                <c:pt idx="66">
                  <c:v>546.78466666666668</c:v>
                </c:pt>
                <c:pt idx="67">
                  <c:v>547.23649999999998</c:v>
                </c:pt>
                <c:pt idx="68">
                  <c:v>547.23649999999998</c:v>
                </c:pt>
                <c:pt idx="69">
                  <c:v>548.59199999999998</c:v>
                </c:pt>
                <c:pt idx="70">
                  <c:v>548.59199999999998</c:v>
                </c:pt>
                <c:pt idx="71">
                  <c:v>549.49566666666658</c:v>
                </c:pt>
                <c:pt idx="72">
                  <c:v>550.3993333333334</c:v>
                </c:pt>
                <c:pt idx="73">
                  <c:v>551.75483333333329</c:v>
                </c:pt>
                <c:pt idx="74">
                  <c:v>552.6585</c:v>
                </c:pt>
                <c:pt idx="75">
                  <c:v>553.56216666666671</c:v>
                </c:pt>
                <c:pt idx="76">
                  <c:v>554.46583333333331</c:v>
                </c:pt>
                <c:pt idx="77">
                  <c:v>554.91766666666661</c:v>
                </c:pt>
                <c:pt idx="78">
                  <c:v>554.91766666666672</c:v>
                </c:pt>
                <c:pt idx="79">
                  <c:v>554.91766666666672</c:v>
                </c:pt>
                <c:pt idx="80">
                  <c:v>555.82133333333331</c:v>
                </c:pt>
                <c:pt idx="81">
                  <c:v>557.62866666666673</c:v>
                </c:pt>
                <c:pt idx="82">
                  <c:v>558.08050000000003</c:v>
                </c:pt>
                <c:pt idx="83">
                  <c:v>559.43600000000004</c:v>
                </c:pt>
                <c:pt idx="84">
                  <c:v>562.59883333333335</c:v>
                </c:pt>
                <c:pt idx="85">
                  <c:v>563.05066666666664</c:v>
                </c:pt>
                <c:pt idx="86">
                  <c:v>564.85800000000006</c:v>
                </c:pt>
                <c:pt idx="87">
                  <c:v>568.02083333333337</c:v>
                </c:pt>
                <c:pt idx="88">
                  <c:v>570.28</c:v>
                </c:pt>
                <c:pt idx="89">
                  <c:v>578.86483333333342</c:v>
                </c:pt>
                <c:pt idx="90">
                  <c:v>583.83500000000004</c:v>
                </c:pt>
                <c:pt idx="91">
                  <c:v>585.64233333333334</c:v>
                </c:pt>
                <c:pt idx="92">
                  <c:v>588.35333333333335</c:v>
                </c:pt>
                <c:pt idx="93">
                  <c:v>591.06433333333337</c:v>
                </c:pt>
                <c:pt idx="94">
                  <c:v>594.22716666666668</c:v>
                </c:pt>
                <c:pt idx="95">
                  <c:v>599.1973333333334</c:v>
                </c:pt>
                <c:pt idx="96">
                  <c:v>609.43888888888887</c:v>
                </c:pt>
              </c:numCache>
            </c:numRef>
          </c:xVal>
          <c:yVal>
            <c:numRef>
              <c:f>'◎高容積重データ (NIR+フィールド)'!$L$3:$L$99</c:f>
              <c:numCache>
                <c:formatCode>0.0000_ </c:formatCode>
                <c:ptCount val="97"/>
                <c:pt idx="0">
                  <c:v>24.103249999999999</c:v>
                </c:pt>
                <c:pt idx="1">
                  <c:v>25.256525</c:v>
                </c:pt>
                <c:pt idx="2">
                  <c:v>29.844262499999999</c:v>
                </c:pt>
                <c:pt idx="3">
                  <c:v>24.421849999999999</c:v>
                </c:pt>
                <c:pt idx="4">
                  <c:v>27.296399999999998</c:v>
                </c:pt>
                <c:pt idx="5">
                  <c:v>22.728125000000002</c:v>
                </c:pt>
                <c:pt idx="6">
                  <c:v>31.4864125</c:v>
                </c:pt>
                <c:pt idx="7">
                  <c:v>34.180143749999999</c:v>
                </c:pt>
                <c:pt idx="8">
                  <c:v>24.69115</c:v>
                </c:pt>
                <c:pt idx="9">
                  <c:v>24.118725000000001</c:v>
                </c:pt>
                <c:pt idx="10">
                  <c:v>27.84675</c:v>
                </c:pt>
                <c:pt idx="11">
                  <c:v>28.017599999999998</c:v>
                </c:pt>
                <c:pt idx="12">
                  <c:v>27.630400000000002</c:v>
                </c:pt>
                <c:pt idx="13">
                  <c:v>26.841749999999998</c:v>
                </c:pt>
                <c:pt idx="14">
                  <c:v>26.249600000000001</c:v>
                </c:pt>
                <c:pt idx="15">
                  <c:v>31.179362500000003</c:v>
                </c:pt>
                <c:pt idx="16">
                  <c:v>25.235049999999998</c:v>
                </c:pt>
                <c:pt idx="17">
                  <c:v>30.501449999999998</c:v>
                </c:pt>
                <c:pt idx="18">
                  <c:v>27.716999999999999</c:v>
                </c:pt>
                <c:pt idx="19">
                  <c:v>25.553325000000001</c:v>
                </c:pt>
                <c:pt idx="20">
                  <c:v>27.729925000000001</c:v>
                </c:pt>
                <c:pt idx="21">
                  <c:v>24.047025000000001</c:v>
                </c:pt>
                <c:pt idx="22">
                  <c:v>28.286787499999999</c:v>
                </c:pt>
                <c:pt idx="23">
                  <c:v>29.089481249999999</c:v>
                </c:pt>
                <c:pt idx="24">
                  <c:v>27.006399999999999</c:v>
                </c:pt>
                <c:pt idx="25">
                  <c:v>31.0274</c:v>
                </c:pt>
                <c:pt idx="26">
                  <c:v>27.049249999999997</c:v>
                </c:pt>
                <c:pt idx="27">
                  <c:v>26.300274999999999</c:v>
                </c:pt>
                <c:pt idx="28">
                  <c:v>26.151475000000001</c:v>
                </c:pt>
                <c:pt idx="29">
                  <c:v>27.588825</c:v>
                </c:pt>
                <c:pt idx="30">
                  <c:v>29.011875</c:v>
                </c:pt>
                <c:pt idx="31">
                  <c:v>24.587125</c:v>
                </c:pt>
                <c:pt idx="32">
                  <c:v>27.439210416666668</c:v>
                </c:pt>
                <c:pt idx="33">
                  <c:v>30.006937499999999</c:v>
                </c:pt>
                <c:pt idx="34">
                  <c:v>27.016424999999998</c:v>
                </c:pt>
                <c:pt idx="35">
                  <c:v>27.9772</c:v>
                </c:pt>
                <c:pt idx="36">
                  <c:v>25.902999999999999</c:v>
                </c:pt>
                <c:pt idx="37">
                  <c:v>26.137574999999998</c:v>
                </c:pt>
                <c:pt idx="38">
                  <c:v>25.282774999999997</c:v>
                </c:pt>
                <c:pt idx="39">
                  <c:v>30.803874999999998</c:v>
                </c:pt>
                <c:pt idx="40">
                  <c:v>27.475349999999999</c:v>
                </c:pt>
                <c:pt idx="41">
                  <c:v>26.859500000000001</c:v>
                </c:pt>
                <c:pt idx="42">
                  <c:v>25.167850000000001</c:v>
                </c:pt>
                <c:pt idx="43">
                  <c:v>25.661200000000001</c:v>
                </c:pt>
                <c:pt idx="44">
                  <c:v>26.008524999999999</c:v>
                </c:pt>
                <c:pt idx="45">
                  <c:v>27.638224999999998</c:v>
                </c:pt>
                <c:pt idx="46">
                  <c:v>26.875475000000002</c:v>
                </c:pt>
                <c:pt idx="47">
                  <c:v>28.209924999999998</c:v>
                </c:pt>
                <c:pt idx="48">
                  <c:v>27.309793749999997</c:v>
                </c:pt>
                <c:pt idx="49">
                  <c:v>21.9527</c:v>
                </c:pt>
                <c:pt idx="50">
                  <c:v>26.261649999999999</c:v>
                </c:pt>
                <c:pt idx="51">
                  <c:v>25.089275000000001</c:v>
                </c:pt>
                <c:pt idx="52">
                  <c:v>28.441775</c:v>
                </c:pt>
                <c:pt idx="53">
                  <c:v>28.925637499999997</c:v>
                </c:pt>
                <c:pt idx="54">
                  <c:v>29.331975000000003</c:v>
                </c:pt>
                <c:pt idx="55">
                  <c:v>32.569175000000001</c:v>
                </c:pt>
                <c:pt idx="56">
                  <c:v>30.0871</c:v>
                </c:pt>
                <c:pt idx="57">
                  <c:v>26.646843750000002</c:v>
                </c:pt>
                <c:pt idx="58">
                  <c:v>27.560575</c:v>
                </c:pt>
                <c:pt idx="59">
                  <c:v>31.383637499999999</c:v>
                </c:pt>
                <c:pt idx="60">
                  <c:v>25.106225000000002</c:v>
                </c:pt>
                <c:pt idx="61">
                  <c:v>27.226925000000001</c:v>
                </c:pt>
                <c:pt idx="62">
                  <c:v>28.554349999999999</c:v>
                </c:pt>
                <c:pt idx="63">
                  <c:v>27.309624999999997</c:v>
                </c:pt>
                <c:pt idx="64">
                  <c:v>27.937375000000003</c:v>
                </c:pt>
                <c:pt idx="65">
                  <c:v>28.584756250000002</c:v>
                </c:pt>
                <c:pt idx="66">
                  <c:v>30.688400000000001</c:v>
                </c:pt>
                <c:pt idx="67">
                  <c:v>31.074600000000004</c:v>
                </c:pt>
                <c:pt idx="68">
                  <c:v>29.192824999999999</c:v>
                </c:pt>
                <c:pt idx="69">
                  <c:v>30.681429166666668</c:v>
                </c:pt>
                <c:pt idx="70">
                  <c:v>30.975337499999998</c:v>
                </c:pt>
                <c:pt idx="71">
                  <c:v>29.146099999999997</c:v>
                </c:pt>
                <c:pt idx="72">
                  <c:v>28.589549999999996</c:v>
                </c:pt>
                <c:pt idx="73">
                  <c:v>25.703575000000001</c:v>
                </c:pt>
                <c:pt idx="74">
                  <c:v>25.496124999999999</c:v>
                </c:pt>
                <c:pt idx="75">
                  <c:v>30.269325000000002</c:v>
                </c:pt>
                <c:pt idx="76">
                  <c:v>30.197400000000002</c:v>
                </c:pt>
                <c:pt idx="77">
                  <c:v>31.815574999999999</c:v>
                </c:pt>
                <c:pt idx="78">
                  <c:v>27.772500000000001</c:v>
                </c:pt>
                <c:pt idx="79">
                  <c:v>27.783299999999997</c:v>
                </c:pt>
                <c:pt idx="80">
                  <c:v>29.297818749999998</c:v>
                </c:pt>
                <c:pt idx="81">
                  <c:v>28.505099999999999</c:v>
                </c:pt>
                <c:pt idx="82">
                  <c:v>28.471824999999999</c:v>
                </c:pt>
                <c:pt idx="83">
                  <c:v>26.735475000000001</c:v>
                </c:pt>
                <c:pt idx="84">
                  <c:v>27.863</c:v>
                </c:pt>
                <c:pt idx="85">
                  <c:v>26.460175</c:v>
                </c:pt>
                <c:pt idx="86">
                  <c:v>29.051225000000002</c:v>
                </c:pt>
                <c:pt idx="87">
                  <c:v>25.851925000000001</c:v>
                </c:pt>
                <c:pt idx="88">
                  <c:v>24.3386</c:v>
                </c:pt>
                <c:pt idx="89">
                  <c:v>25.846343749999999</c:v>
                </c:pt>
                <c:pt idx="90">
                  <c:v>29.661374999999996</c:v>
                </c:pt>
                <c:pt idx="91">
                  <c:v>31.270256249999996</c:v>
                </c:pt>
                <c:pt idx="92">
                  <c:v>27.893675000000002</c:v>
                </c:pt>
                <c:pt idx="93">
                  <c:v>28.269475</c:v>
                </c:pt>
                <c:pt idx="94">
                  <c:v>29.897100000000002</c:v>
                </c:pt>
                <c:pt idx="95">
                  <c:v>29.764225</c:v>
                </c:pt>
                <c:pt idx="96">
                  <c:v>29.67968125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F3A-4676-BD7A-D768461EC4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250752"/>
        <c:axId val="56252672"/>
      </c:scatterChart>
      <c:valAx>
        <c:axId val="56250752"/>
        <c:scaling>
          <c:orientation val="minMax"/>
          <c:min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ja-JP" sz="90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WBD (kg/m</a:t>
                </a:r>
                <a:r>
                  <a:rPr lang="en-US" altLang="en-US" sz="900" baseline="300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3</a:t>
                </a: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252672"/>
        <c:crosses val="autoZero"/>
        <c:crossBetween val="midCat"/>
      </c:valAx>
      <c:valAx>
        <c:axId val="56252672"/>
        <c:scaling>
          <c:orientation val="minMax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lang="ja-JP" sz="105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105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Klason lignin (%)</a:t>
                </a:r>
              </a:p>
            </c:rich>
          </c:tx>
          <c:layout/>
          <c:overlay val="0"/>
        </c:title>
        <c:numFmt formatCode="0_ 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250752"/>
        <c:crosses val="autoZero"/>
        <c:crossBetween val="midCat"/>
        <c:majorUnit val="4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050" b="1" i="0" u="none" strike="noStrike" kern="1200" spc="0" baseline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defRPr>
            </a:pPr>
            <a:r>
              <a:rPr lang="en-US" altLang="ja-JP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D)  WBD </a:t>
            </a:r>
            <a:r>
              <a:rPr lang="en-US" altLang="ja-JP" sz="1050" b="1" dirty="0" err="1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vs</a:t>
            </a:r>
            <a:r>
              <a:rPr lang="en-US" altLang="ja-JP" sz="1050" b="1" dirty="0">
                <a:solidFill>
                  <a:schemeClr val="tx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Hemicellulose</a:t>
            </a:r>
            <a:endParaRPr lang="ja-JP" altLang="en-US" sz="1050" b="1" dirty="0">
              <a:solidFill>
                <a:schemeClr val="tx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c:rich>
      </c:tx>
      <c:layout>
        <c:manualLayout>
          <c:xMode val="edge"/>
          <c:yMode val="edge"/>
          <c:x val="0.24674763315784703"/>
          <c:y val="9.583573205670749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840574778875303"/>
          <c:y val="0.21856451976716393"/>
          <c:w val="0.66331356191577007"/>
          <c:h val="0.56830512097982377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791902552957933"/>
                  <c:y val="-0.1956832237495497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7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◎高容積重データ (NIR+フィールド)'!$G$3:$G$99</c:f>
              <c:numCache>
                <c:formatCode>General</c:formatCode>
                <c:ptCount val="97"/>
                <c:pt idx="0">
                  <c:v>367.40683333333345</c:v>
                </c:pt>
                <c:pt idx="1">
                  <c:v>377.79900000000009</c:v>
                </c:pt>
                <c:pt idx="2">
                  <c:v>389.54666666666674</c:v>
                </c:pt>
                <c:pt idx="3">
                  <c:v>398.58333333333337</c:v>
                </c:pt>
                <c:pt idx="4">
                  <c:v>408.52366666666666</c:v>
                </c:pt>
                <c:pt idx="5">
                  <c:v>416.20483333333345</c:v>
                </c:pt>
                <c:pt idx="6">
                  <c:v>421.17500000000001</c:v>
                </c:pt>
                <c:pt idx="7">
                  <c:v>422.98233333333337</c:v>
                </c:pt>
                <c:pt idx="8">
                  <c:v>436.53733333333338</c:v>
                </c:pt>
                <c:pt idx="9">
                  <c:v>440.1520000000001</c:v>
                </c:pt>
                <c:pt idx="10">
                  <c:v>460.48450000000008</c:v>
                </c:pt>
                <c:pt idx="11">
                  <c:v>463.64733333333339</c:v>
                </c:pt>
                <c:pt idx="12">
                  <c:v>464.55100000000004</c:v>
                </c:pt>
                <c:pt idx="13">
                  <c:v>466.81016666666676</c:v>
                </c:pt>
                <c:pt idx="14">
                  <c:v>474.03950000000009</c:v>
                </c:pt>
                <c:pt idx="15">
                  <c:v>475.3950000000001</c:v>
                </c:pt>
                <c:pt idx="16">
                  <c:v>477.2023333333334</c:v>
                </c:pt>
                <c:pt idx="17">
                  <c:v>477.2023333333334</c:v>
                </c:pt>
                <c:pt idx="18">
                  <c:v>478.55783333333346</c:v>
                </c:pt>
                <c:pt idx="19">
                  <c:v>479.00966666666676</c:v>
                </c:pt>
                <c:pt idx="20">
                  <c:v>479.91333333333347</c:v>
                </c:pt>
                <c:pt idx="21">
                  <c:v>483.97983333333349</c:v>
                </c:pt>
                <c:pt idx="22">
                  <c:v>486.23899999999998</c:v>
                </c:pt>
                <c:pt idx="23">
                  <c:v>487.5945000000001</c:v>
                </c:pt>
                <c:pt idx="24">
                  <c:v>490.75733333333341</c:v>
                </c:pt>
                <c:pt idx="25">
                  <c:v>491.661</c:v>
                </c:pt>
                <c:pt idx="26">
                  <c:v>493.46833333333342</c:v>
                </c:pt>
                <c:pt idx="27">
                  <c:v>496.17933333333343</c:v>
                </c:pt>
                <c:pt idx="28">
                  <c:v>497.98666666666674</c:v>
                </c:pt>
                <c:pt idx="29">
                  <c:v>498.43850000000015</c:v>
                </c:pt>
                <c:pt idx="30">
                  <c:v>499.79400000000004</c:v>
                </c:pt>
                <c:pt idx="31">
                  <c:v>502.95683333333335</c:v>
                </c:pt>
                <c:pt idx="32">
                  <c:v>505.66783333333336</c:v>
                </c:pt>
                <c:pt idx="33">
                  <c:v>506.11966666666666</c:v>
                </c:pt>
                <c:pt idx="34">
                  <c:v>506.57149999999996</c:v>
                </c:pt>
                <c:pt idx="35">
                  <c:v>506.57149999999996</c:v>
                </c:pt>
                <c:pt idx="36">
                  <c:v>507.02333333333348</c:v>
                </c:pt>
                <c:pt idx="37">
                  <c:v>510.63800000000009</c:v>
                </c:pt>
                <c:pt idx="38">
                  <c:v>511.18019999999996</c:v>
                </c:pt>
                <c:pt idx="39">
                  <c:v>511.54166666666669</c:v>
                </c:pt>
                <c:pt idx="40">
                  <c:v>511.99349999999998</c:v>
                </c:pt>
                <c:pt idx="41">
                  <c:v>511.99349999999998</c:v>
                </c:pt>
                <c:pt idx="42">
                  <c:v>512.89716666666675</c:v>
                </c:pt>
                <c:pt idx="43">
                  <c:v>514.25266666666664</c:v>
                </c:pt>
                <c:pt idx="44">
                  <c:v>514.25266666666664</c:v>
                </c:pt>
                <c:pt idx="45">
                  <c:v>519.67466666666667</c:v>
                </c:pt>
                <c:pt idx="46">
                  <c:v>521.48200000000008</c:v>
                </c:pt>
                <c:pt idx="47">
                  <c:v>522.38566666666668</c:v>
                </c:pt>
                <c:pt idx="48">
                  <c:v>524.64483333333339</c:v>
                </c:pt>
                <c:pt idx="49">
                  <c:v>526.00033333333329</c:v>
                </c:pt>
                <c:pt idx="50">
                  <c:v>526.90400000000011</c:v>
                </c:pt>
                <c:pt idx="51">
                  <c:v>527.35583333333341</c:v>
                </c:pt>
                <c:pt idx="52">
                  <c:v>528.7113333333333</c:v>
                </c:pt>
                <c:pt idx="53">
                  <c:v>529.61500000000001</c:v>
                </c:pt>
                <c:pt idx="54">
                  <c:v>531.42233333333331</c:v>
                </c:pt>
                <c:pt idx="55">
                  <c:v>532.32600000000002</c:v>
                </c:pt>
                <c:pt idx="56">
                  <c:v>535.94066666666674</c:v>
                </c:pt>
                <c:pt idx="57">
                  <c:v>536.39250000000004</c:v>
                </c:pt>
                <c:pt idx="58">
                  <c:v>537.29616666666664</c:v>
                </c:pt>
                <c:pt idx="59">
                  <c:v>537.74800000000005</c:v>
                </c:pt>
                <c:pt idx="60">
                  <c:v>540.91083333333324</c:v>
                </c:pt>
                <c:pt idx="61">
                  <c:v>541.36266666666677</c:v>
                </c:pt>
                <c:pt idx="62">
                  <c:v>541.81450000000007</c:v>
                </c:pt>
                <c:pt idx="63">
                  <c:v>544.07366666666655</c:v>
                </c:pt>
                <c:pt idx="64">
                  <c:v>544.97733333333338</c:v>
                </c:pt>
                <c:pt idx="65">
                  <c:v>545.88099999999997</c:v>
                </c:pt>
                <c:pt idx="66">
                  <c:v>546.78466666666668</c:v>
                </c:pt>
                <c:pt idx="67">
                  <c:v>547.23649999999998</c:v>
                </c:pt>
                <c:pt idx="68">
                  <c:v>547.23649999999998</c:v>
                </c:pt>
                <c:pt idx="69">
                  <c:v>548.59199999999998</c:v>
                </c:pt>
                <c:pt idx="70">
                  <c:v>548.59199999999998</c:v>
                </c:pt>
                <c:pt idx="71">
                  <c:v>549.49566666666658</c:v>
                </c:pt>
                <c:pt idx="72">
                  <c:v>550.3993333333334</c:v>
                </c:pt>
                <c:pt idx="73">
                  <c:v>551.75483333333329</c:v>
                </c:pt>
                <c:pt idx="74">
                  <c:v>552.6585</c:v>
                </c:pt>
                <c:pt idx="75">
                  <c:v>553.56216666666671</c:v>
                </c:pt>
                <c:pt idx="76">
                  <c:v>554.46583333333331</c:v>
                </c:pt>
                <c:pt idx="77">
                  <c:v>554.91766666666661</c:v>
                </c:pt>
                <c:pt idx="78">
                  <c:v>554.91766666666672</c:v>
                </c:pt>
                <c:pt idx="79">
                  <c:v>554.91766666666672</c:v>
                </c:pt>
                <c:pt idx="80">
                  <c:v>555.82133333333331</c:v>
                </c:pt>
                <c:pt idx="81">
                  <c:v>557.62866666666673</c:v>
                </c:pt>
                <c:pt idx="82">
                  <c:v>558.08050000000003</c:v>
                </c:pt>
                <c:pt idx="83">
                  <c:v>559.43600000000004</c:v>
                </c:pt>
                <c:pt idx="84">
                  <c:v>562.59883333333335</c:v>
                </c:pt>
                <c:pt idx="85">
                  <c:v>563.05066666666664</c:v>
                </c:pt>
                <c:pt idx="86">
                  <c:v>564.85800000000006</c:v>
                </c:pt>
                <c:pt idx="87">
                  <c:v>568.02083333333337</c:v>
                </c:pt>
                <c:pt idx="88">
                  <c:v>570.28</c:v>
                </c:pt>
                <c:pt idx="89">
                  <c:v>578.86483333333342</c:v>
                </c:pt>
                <c:pt idx="90">
                  <c:v>583.83500000000004</c:v>
                </c:pt>
                <c:pt idx="91">
                  <c:v>585.64233333333334</c:v>
                </c:pt>
                <c:pt idx="92">
                  <c:v>588.35333333333335</c:v>
                </c:pt>
                <c:pt idx="93">
                  <c:v>591.06433333333337</c:v>
                </c:pt>
                <c:pt idx="94">
                  <c:v>594.22716666666668</c:v>
                </c:pt>
                <c:pt idx="95">
                  <c:v>599.1973333333334</c:v>
                </c:pt>
                <c:pt idx="96">
                  <c:v>609.43888888888887</c:v>
                </c:pt>
              </c:numCache>
            </c:numRef>
          </c:xVal>
          <c:yVal>
            <c:numRef>
              <c:f>'◎高容積重データ (NIR+フィールド)'!$P$3:$P$99</c:f>
              <c:numCache>
                <c:formatCode>0.0000_ </c:formatCode>
                <c:ptCount val="97"/>
                <c:pt idx="0">
                  <c:v>23.484575</c:v>
                </c:pt>
                <c:pt idx="1">
                  <c:v>31.208024999999999</c:v>
                </c:pt>
                <c:pt idx="2">
                  <c:v>25.433162500000002</c:v>
                </c:pt>
                <c:pt idx="3">
                  <c:v>28.739649999999997</c:v>
                </c:pt>
                <c:pt idx="4">
                  <c:v>24.378050000000002</c:v>
                </c:pt>
                <c:pt idx="5">
                  <c:v>27.122106250000002</c:v>
                </c:pt>
                <c:pt idx="6">
                  <c:v>28.955143749999998</c:v>
                </c:pt>
                <c:pt idx="7">
                  <c:v>28.667550000000002</c:v>
                </c:pt>
                <c:pt idx="8">
                  <c:v>25.74775</c:v>
                </c:pt>
                <c:pt idx="9">
                  <c:v>25.944950000000002</c:v>
                </c:pt>
                <c:pt idx="10">
                  <c:v>27.280349999999999</c:v>
                </c:pt>
                <c:pt idx="11">
                  <c:v>26.616999999999997</c:v>
                </c:pt>
                <c:pt idx="12">
                  <c:v>27.428525</c:v>
                </c:pt>
                <c:pt idx="13">
                  <c:v>26.9269</c:v>
                </c:pt>
                <c:pt idx="14">
                  <c:v>25.340624999999999</c:v>
                </c:pt>
                <c:pt idx="15">
                  <c:v>25.725593749999998</c:v>
                </c:pt>
                <c:pt idx="16">
                  <c:v>21.216850000000001</c:v>
                </c:pt>
                <c:pt idx="17">
                  <c:v>23.850381250000002</c:v>
                </c:pt>
                <c:pt idx="18">
                  <c:v>24.688175000000001</c:v>
                </c:pt>
                <c:pt idx="19">
                  <c:v>20.657024999999997</c:v>
                </c:pt>
                <c:pt idx="20">
                  <c:v>30.095324999999999</c:v>
                </c:pt>
                <c:pt idx="21">
                  <c:v>27.997949999999999</c:v>
                </c:pt>
                <c:pt idx="22">
                  <c:v>26.2979375</c:v>
                </c:pt>
                <c:pt idx="23">
                  <c:v>31.673849999999998</c:v>
                </c:pt>
                <c:pt idx="24">
                  <c:v>28.3063</c:v>
                </c:pt>
                <c:pt idx="25">
                  <c:v>29.14255</c:v>
                </c:pt>
                <c:pt idx="26">
                  <c:v>24.393375000000002</c:v>
                </c:pt>
                <c:pt idx="27">
                  <c:v>27.077625000000001</c:v>
                </c:pt>
                <c:pt idx="28">
                  <c:v>23.693300000000001</c:v>
                </c:pt>
                <c:pt idx="29">
                  <c:v>32.068600000000004</c:v>
                </c:pt>
                <c:pt idx="30">
                  <c:v>29.316075000000001</c:v>
                </c:pt>
                <c:pt idx="31">
                  <c:v>23.709299999999999</c:v>
                </c:pt>
                <c:pt idx="32">
                  <c:v>28.989197916666665</c:v>
                </c:pt>
                <c:pt idx="33">
                  <c:v>28.075981250000002</c:v>
                </c:pt>
                <c:pt idx="34">
                  <c:v>25.800425000000001</c:v>
                </c:pt>
                <c:pt idx="35">
                  <c:v>26.874925000000001</c:v>
                </c:pt>
                <c:pt idx="36">
                  <c:v>29.204849999999997</c:v>
                </c:pt>
                <c:pt idx="37">
                  <c:v>28.411925</c:v>
                </c:pt>
                <c:pt idx="38">
                  <c:v>24.764300000000002</c:v>
                </c:pt>
                <c:pt idx="39">
                  <c:v>28.056899999999999</c:v>
                </c:pt>
                <c:pt idx="40">
                  <c:v>26.172775000000001</c:v>
                </c:pt>
                <c:pt idx="41">
                  <c:v>26.697625000000002</c:v>
                </c:pt>
                <c:pt idx="42">
                  <c:v>23.312975000000002</c:v>
                </c:pt>
                <c:pt idx="43">
                  <c:v>25.320225000000001</c:v>
                </c:pt>
                <c:pt idx="44">
                  <c:v>27.212475000000001</c:v>
                </c:pt>
                <c:pt idx="45">
                  <c:v>29.490099999999998</c:v>
                </c:pt>
                <c:pt idx="46">
                  <c:v>26.306024999999998</c:v>
                </c:pt>
                <c:pt idx="47">
                  <c:v>30.307699999999997</c:v>
                </c:pt>
                <c:pt idx="48">
                  <c:v>27.930487499999998</c:v>
                </c:pt>
                <c:pt idx="49">
                  <c:v>28.996375</c:v>
                </c:pt>
                <c:pt idx="50">
                  <c:v>30.702974999999999</c:v>
                </c:pt>
                <c:pt idx="51">
                  <c:v>25.882149999999999</c:v>
                </c:pt>
                <c:pt idx="52">
                  <c:v>29.292349999999999</c:v>
                </c:pt>
                <c:pt idx="53">
                  <c:v>25.240087499999998</c:v>
                </c:pt>
                <c:pt idx="54">
                  <c:v>24.733125000000001</c:v>
                </c:pt>
                <c:pt idx="55">
                  <c:v>26.689562499999997</c:v>
                </c:pt>
                <c:pt idx="56">
                  <c:v>23.340024999999997</c:v>
                </c:pt>
                <c:pt idx="57">
                  <c:v>20.824337500000002</c:v>
                </c:pt>
                <c:pt idx="58">
                  <c:v>27.263624999999998</c:v>
                </c:pt>
                <c:pt idx="59">
                  <c:v>30.499568750000002</c:v>
                </c:pt>
                <c:pt idx="60">
                  <c:v>27.315999999999999</c:v>
                </c:pt>
                <c:pt idx="61">
                  <c:v>26.345549999999999</c:v>
                </c:pt>
                <c:pt idx="62">
                  <c:v>22.575900000000001</c:v>
                </c:pt>
                <c:pt idx="63">
                  <c:v>23.995849999999997</c:v>
                </c:pt>
                <c:pt idx="64">
                  <c:v>25.999099999999999</c:v>
                </c:pt>
                <c:pt idx="65">
                  <c:v>34.988950000000003</c:v>
                </c:pt>
                <c:pt idx="66">
                  <c:v>26.873841666666664</c:v>
                </c:pt>
                <c:pt idx="67">
                  <c:v>22.318524999999998</c:v>
                </c:pt>
                <c:pt idx="68">
                  <c:v>26.325375000000001</c:v>
                </c:pt>
                <c:pt idx="69">
                  <c:v>28.957210416666669</c:v>
                </c:pt>
                <c:pt idx="70">
                  <c:v>26.674824999999998</c:v>
                </c:pt>
                <c:pt idx="71">
                  <c:v>28.269324999999998</c:v>
                </c:pt>
                <c:pt idx="72">
                  <c:v>27.431875000000002</c:v>
                </c:pt>
                <c:pt idx="73">
                  <c:v>29.515999999999998</c:v>
                </c:pt>
                <c:pt idx="74">
                  <c:v>25.359874999999999</c:v>
                </c:pt>
                <c:pt idx="75">
                  <c:v>28.616700000000002</c:v>
                </c:pt>
                <c:pt idx="76">
                  <c:v>27.144199999999998</c:v>
                </c:pt>
                <c:pt idx="77">
                  <c:v>24.355775000000001</c:v>
                </c:pt>
                <c:pt idx="78">
                  <c:v>26.405875000000002</c:v>
                </c:pt>
                <c:pt idx="79">
                  <c:v>28.419975000000001</c:v>
                </c:pt>
                <c:pt idx="80">
                  <c:v>29.580337499999999</c:v>
                </c:pt>
                <c:pt idx="81">
                  <c:v>30.18675</c:v>
                </c:pt>
                <c:pt idx="82">
                  <c:v>27.630924999999998</c:v>
                </c:pt>
                <c:pt idx="83">
                  <c:v>27.903600000000001</c:v>
                </c:pt>
                <c:pt idx="84">
                  <c:v>25.223074999999998</c:v>
                </c:pt>
                <c:pt idx="85">
                  <c:v>25.793950000000002</c:v>
                </c:pt>
                <c:pt idx="86">
                  <c:v>23.797725</c:v>
                </c:pt>
                <c:pt idx="87">
                  <c:v>25.924050000000001</c:v>
                </c:pt>
                <c:pt idx="88">
                  <c:v>24.071650000000002</c:v>
                </c:pt>
                <c:pt idx="89">
                  <c:v>22.760393749999999</c:v>
                </c:pt>
                <c:pt idx="90">
                  <c:v>28.587325</c:v>
                </c:pt>
                <c:pt idx="91">
                  <c:v>26.413968750000002</c:v>
                </c:pt>
                <c:pt idx="92">
                  <c:v>28.731725000000001</c:v>
                </c:pt>
                <c:pt idx="93">
                  <c:v>26.903174999999997</c:v>
                </c:pt>
                <c:pt idx="94">
                  <c:v>28.873268750000001</c:v>
                </c:pt>
                <c:pt idx="95">
                  <c:v>26.648774999999997</c:v>
                </c:pt>
                <c:pt idx="96">
                  <c:v>30.6790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753-4D75-8FDF-59BFC1F4C5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795136"/>
        <c:axId val="62805504"/>
      </c:scatterChart>
      <c:valAx>
        <c:axId val="62795136"/>
        <c:scaling>
          <c:orientation val="minMax"/>
          <c:min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ja-JP" sz="90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WBD (kg/m</a:t>
                </a:r>
                <a:r>
                  <a:rPr lang="en-US" altLang="en-US" sz="900" baseline="300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3</a:t>
                </a:r>
                <a:r>
                  <a:rPr lang="en-US" altLang="en-US" sz="9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805504"/>
        <c:crosses val="autoZero"/>
        <c:crossBetween val="midCat"/>
      </c:valAx>
      <c:valAx>
        <c:axId val="62805504"/>
        <c:scaling>
          <c:orientation val="minMax"/>
          <c:min val="1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lang="ja-JP" sz="105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defRPr>
                </a:pPr>
                <a:r>
                  <a:rPr lang="en-US" altLang="en-US" sz="105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Hemicellulose (%)</a:t>
                </a:r>
              </a:p>
            </c:rich>
          </c:tx>
          <c:layout/>
          <c:overlay val="0"/>
        </c:title>
        <c:numFmt formatCode="0_ 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795136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8079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629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9489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36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199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2976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458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800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32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946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068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186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636912" y="5580112"/>
            <a:ext cx="1872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Additional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File: Figure S1</a:t>
            </a:r>
            <a:endParaRPr lang="ja-JP" altLang="ja-JP" sz="1200" dirty="0"/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5639569"/>
              </p:ext>
            </p:extLst>
          </p:nvPr>
        </p:nvGraphicFramePr>
        <p:xfrm>
          <a:off x="547544" y="251520"/>
          <a:ext cx="2880320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0844403"/>
              </p:ext>
            </p:extLst>
          </p:nvPr>
        </p:nvGraphicFramePr>
        <p:xfrm>
          <a:off x="3429000" y="251520"/>
          <a:ext cx="2964681" cy="2448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7612655"/>
              </p:ext>
            </p:extLst>
          </p:nvPr>
        </p:nvGraphicFramePr>
        <p:xfrm>
          <a:off x="548681" y="2699793"/>
          <a:ext cx="2880320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1762116"/>
              </p:ext>
            </p:extLst>
          </p:nvPr>
        </p:nvGraphicFramePr>
        <p:xfrm>
          <a:off x="3457073" y="2699793"/>
          <a:ext cx="2924255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293812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61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okas</dc:creator>
  <cp:lastModifiedBy>Barillo, Ian Benedict</cp:lastModifiedBy>
  <cp:revision>8</cp:revision>
  <dcterms:created xsi:type="dcterms:W3CDTF">2017-04-09T23:53:56Z</dcterms:created>
  <dcterms:modified xsi:type="dcterms:W3CDTF">2018-07-31T08:44:58Z</dcterms:modified>
</cp:coreProperties>
</file>